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_Danh_SNS032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34"/>
    <p:restoredTop sz="94660"/>
  </p:normalViewPr>
  <p:slideViewPr>
    <p:cSldViewPr snapToGrid="0">
      <p:cViewPr varScale="1">
        <p:scale>
          <a:sx n="95" d="100"/>
          <a:sy n="95" d="100"/>
        </p:scale>
        <p:origin x="200" y="6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463932-C9DB-8867-ED88-FE5E1C7AC3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92A5D7-DA57-7D3B-AFC6-B853656BB4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D537F8-513E-A196-F880-1C71D1456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FA8876-8875-0177-A2F2-1D6763A1F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5F1A45-BA38-B955-890C-D8567A763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161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E115EA-1229-D869-C2C3-F30FE12AA0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EEEA74-E525-D5CC-45BB-6D2DE02FED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02979C-7C25-9726-110D-FA55D8FEB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B857C7-2DE9-AF5C-6055-B9E94F154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75F370-3924-31DF-316E-017AC67B2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600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C1713A-89E6-5399-C843-95DAB5B128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8DDCA3-080E-6564-D75C-6A18CD043E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785DF-3352-A941-66AD-AA812AB00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AB3719-20E3-1966-11E8-31CEF8968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5B860A-E306-C786-4575-2042C2ABD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049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CE4F17-EEC1-45A4-B790-AB74405DC7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F9012E-A803-9EEC-A115-B840943EC7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A7673C-E24B-4692-CDBB-192BF718C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CC0427-CE51-60A9-AFD4-70896B471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1CDBBD-9477-24F0-7359-1D711A86E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373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A0A292-60CC-4139-51AB-1B1DA66486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641B0F-24ED-B7E5-85AC-0DE34FB839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1D12D2-31AD-FDDF-FF74-DA7C09C9F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CECBF0-77EC-3265-AA42-6D349D815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F9671A-CC46-481E-3B7A-F47153C78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225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4B65EE-6EC7-6F33-40F6-0C6E9D4793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D4E618-B8F7-4BA1-80DE-0E852A267B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92E658-5586-FCD9-5CCD-5ED7F90A24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D3291D-1106-A6CC-53DB-1DCBA4129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4609CD-C1B3-7732-290C-3F5F9C3B4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3E151D-F49B-BAE4-3AD8-B10A0B7A3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930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B6335A-E5EC-87C7-479D-0D76C936C1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F1B7C8-14AE-ECE0-C20B-E998A29698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18FDB9-FF64-2A8A-1AA4-2E3BBB8EE2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A9FD5E-8780-0EF5-AE02-E79C3E61AA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03A54AE-6EB8-7394-C275-5AB9FBD7B4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AC0037-E58C-47E5-3635-21D2CAB10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877F8C5-45D7-A552-CC67-6B5C8DAC8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614F25-3739-7C67-EC1B-5D885675B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5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C753C5-9834-32D5-2D8C-89F12A1B73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C85EDE-CFBA-0E31-846B-AA67845F3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9956F1-36B1-37E6-1941-CB8972416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7E3D84-04EA-6E81-7F99-8780AB129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603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8230E0-357B-BF1D-78A3-1F9CB083F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D78E71-6997-4F0E-14DE-B3E662C34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FB1EC0-641E-8F98-0CE3-5A0B80815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18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0F0C5-E075-5A01-D60F-7ACE948C54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22ABD6-40B4-03CD-21A3-877B9B7596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9ECB4E-B202-1178-15B4-45857EA94C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FB4014-B337-25A5-926A-06D0FD4CE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E19E2E-C23D-C88E-C195-84D2AC0EB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24CDC8-BB0D-11BB-BCC0-0201CB5CD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7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9A9AEC-3CA5-D86A-24AE-FE3C5FBDD7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C683084-6108-9BBB-A0D3-1F782B03BF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5915C4-C372-61CD-C695-11674EFBCD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2D5373-A9A7-6ED4-5E55-C82744F93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FC885C-6CD4-66C9-0208-185D2AD7D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CB01FC-C5FE-9B6E-64D3-506FAF44B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587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CC2430B-496C-EB8D-F456-2DE56BA72C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85DF8F-2A72-852B-42A0-E11B2023F3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A18DB6-1D63-6623-4A5C-E46F85A768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5169F2-D188-5A4F-ABD2-E17758118EC2}" type="datetimeFigureOut">
              <a:rPr lang="en-US" smtClean="0"/>
              <a:t>3/24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5D1848-3E76-0BFC-A051-5CB27FD3DC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78AAF4-E91B-2DB4-DDCB-32C9508B9E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3AF9E7-04F3-1C45-A556-00A601565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574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_Danh_SNS032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hart of different colors&#10;&#10;Description automatically generated">
            <a:extLst>
              <a:ext uri="{FF2B5EF4-FFF2-40B4-BE49-F238E27FC236}">
                <a16:creationId xmlns:a16="http://schemas.microsoft.com/office/drawing/2014/main" id="{1FFE37D8-AB31-FDA5-403D-FAB063E1FB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0063" y="2000250"/>
            <a:ext cx="3571875" cy="28575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C1B233B-17E0-909A-5481-5FE64E919C50}"/>
              </a:ext>
            </a:extLst>
          </p:cNvPr>
          <p:cNvSpPr txBox="1"/>
          <p:nvPr/>
        </p:nvSpPr>
        <p:spPr>
          <a:xfrm>
            <a:off x="3922971" y="5355602"/>
            <a:ext cx="4237074" cy="529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2. Heatmap of the</a:t>
            </a:r>
            <a:r>
              <a:rPr lang="en-US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DK2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K7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nd </a:t>
            </a:r>
            <a:r>
              <a:rPr lang="en-US" sz="9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K9</a:t>
            </a: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in sarcoma cells from the Cancer Cell Line Encyclopedia (CCLE) database. AUC: Area Under the Curve values from our drug screen.</a:t>
            </a:r>
            <a:endParaRPr lang="en-US" sz="9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29997DE-5EAF-F6D6-81BC-AD3E033DD168}"/>
              </a:ext>
            </a:extLst>
          </p:cNvPr>
          <p:cNvSpPr txBox="1"/>
          <p:nvPr/>
        </p:nvSpPr>
        <p:spPr>
          <a:xfrm>
            <a:off x="7922643" y="53164"/>
            <a:ext cx="7938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uppl. Fig. 2</a:t>
            </a:r>
          </a:p>
        </p:txBody>
      </p:sp>
    </p:spTree>
    <p:extLst>
      <p:ext uri="{BB962C8B-B14F-4D97-AF65-F5344CB8AC3E}">
        <p14:creationId xmlns:p14="http://schemas.microsoft.com/office/powerpoint/2010/main" val="2709348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5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ird,Hannah C</dc:creator>
  <cp:lastModifiedBy>Beird,Hannah C</cp:lastModifiedBy>
  <cp:revision>1</cp:revision>
  <dcterms:created xsi:type="dcterms:W3CDTF">2026-03-24T14:06:48Z</dcterms:created>
  <dcterms:modified xsi:type="dcterms:W3CDTF">2026-03-24T14:07:56Z</dcterms:modified>
</cp:coreProperties>
</file>